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xlsx" ContentType="application/vnd.openxmlformats-officedocument.spreadsheetml.sheet"/>
  <Default Extension="vml" ContentType="application/vnd.openxmlformats-officedocument.vmlDrawing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5"/>
  </p:handoutMasterIdLst>
  <p:sldIdLst>
    <p:sldId id="280" r:id="rId2"/>
    <p:sldId id="281" r:id="rId3"/>
    <p:sldId id="272" r:id="rId4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681" autoAdjust="0"/>
    <p:restoredTop sz="94660"/>
  </p:normalViewPr>
  <p:slideViewPr>
    <p:cSldViewPr snapToGrid="0">
      <p:cViewPr>
        <p:scale>
          <a:sx n="75" d="100"/>
          <a:sy n="75" d="100"/>
        </p:scale>
        <p:origin x="-1936" y="-80"/>
      </p:cViewPr>
      <p:guideLst>
        <p:guide orient="horz" pos="2776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handoutMaster" Target="handoutMasters/handout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BB2D31-3981-424C-849F-C2CFD1EF4056}" type="datetimeFigureOut">
              <a:rPr lang="en-US" smtClean="0"/>
              <a:t>6/1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8351D7-3514-49D3-9647-83BB60F62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5152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06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082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68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37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233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981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01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745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065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20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E65CD-9895-4203-96C5-5FC51E850358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368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package" Target="../embeddings/Microsoft_Excel_Sheet1.xlsx"/><Relationship Id="rId5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1195302"/>
              </p:ext>
            </p:extLst>
          </p:nvPr>
        </p:nvGraphicFramePr>
        <p:xfrm>
          <a:off x="740093" y="2492897"/>
          <a:ext cx="5375910" cy="2804160"/>
        </p:xfrm>
        <a:graphic>
          <a:graphicData uri="http://schemas.openxmlformats.org/drawingml/2006/table">
            <a:tbl>
              <a:tblPr firstRow="1" firstCol="1" bandRow="1"/>
              <a:tblGrid>
                <a:gridCol w="63150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2424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5504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5504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5504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95504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46736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ontrol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pv4cl1-25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pv4cl1-26</a:t>
                      </a:r>
                      <a:endParaRPr lang="en-US" altLang="ko-KR" sz="12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pv4cl1-29</a:t>
                      </a:r>
                      <a:endParaRPr lang="en-US" altLang="ko-KR" sz="12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1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1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1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1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Hydroxycinnamates</a:t>
                      </a:r>
                      <a:r>
                        <a:rPr lang="en-US" sz="1200" i="0" baseline="300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</a:t>
                      </a:r>
                      <a:endParaRPr lang="en-US" sz="1200" i="0" dirty="0" smtClean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33680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A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/S+G+H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/S+G+H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33680">
                <a:tc v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0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2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5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2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33680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CA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/S+G+H</a:t>
                      </a: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33680">
                <a:tc v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4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5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0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44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Inter-linkages</a:t>
                      </a:r>
                      <a:endParaRPr lang="en-US" sz="12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[%]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O-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8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1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3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7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1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1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3368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β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645001" y="5721431"/>
            <a:ext cx="5567997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A and </a:t>
            </a:r>
            <a:r>
              <a:rPr lang="en-US" alt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CA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ompositions are expressed as a fraction of total lignin subunits (S+G+H); FA: ferulate; </a:t>
            </a:r>
            <a:r>
              <a:rPr lang="en-US" alt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CA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p-</a:t>
            </a:r>
            <a:r>
              <a:rPr lang="en-US" alt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umarate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; β-O-4: β-aryl ether; β-5: </a:t>
            </a:r>
            <a:r>
              <a:rPr lang="en-US" alt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henylcoumaran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; β-β: </a:t>
            </a:r>
            <a:r>
              <a:rPr lang="en-US" alt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sinol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43467" y="1859764"/>
            <a:ext cx="5994400" cy="5847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emi-quantitative analysis </a:t>
            </a:r>
            <a:r>
              <a:rPr lang="en-US" altLang="en-US" sz="16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hydroxycinnamates</a:t>
            </a:r>
            <a:r>
              <a:rPr lang="en-US" alt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nd inter-linkages in switchgrass</a:t>
            </a:r>
            <a:r>
              <a:rPr lang="en-US" alt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</a:t>
            </a:r>
            <a:r>
              <a:rPr lang="en-US" alt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643467" y="1339336"/>
            <a:ext cx="18518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75633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9373802"/>
              </p:ext>
            </p:extLst>
          </p:nvPr>
        </p:nvGraphicFramePr>
        <p:xfrm>
          <a:off x="448385" y="3051810"/>
          <a:ext cx="5872405" cy="2271828"/>
        </p:xfrm>
        <a:graphic>
          <a:graphicData uri="http://schemas.openxmlformats.org/drawingml/2006/table">
            <a:tbl>
              <a:tblPr firstRow="1" firstCol="1" bandRow="1"/>
              <a:tblGrid>
                <a:gridCol w="126822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15104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15104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15104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151044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351738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arbohydrat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ontrol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-25</a:t>
                      </a:r>
                      <a:endParaRPr lang="en-US" sz="16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-26</a:t>
                      </a:r>
                      <a:endParaRPr lang="en-US" sz="16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-29</a:t>
                      </a:r>
                      <a:endParaRPr lang="en-US" sz="16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704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6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6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%]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6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6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%]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6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6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%]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60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t-wt</a:t>
                      </a:r>
                      <a:r>
                        <a:rPr lang="en-US" sz="16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6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%]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49441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Glucos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3.7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2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4.9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3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4.1</a:t>
                      </a: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1.4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4.0</a:t>
                      </a: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4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5173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Xylos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1.5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6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2.9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3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3.1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1.6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2.6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6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5173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Arabinos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.8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4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1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4.3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5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.8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6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5173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Galactos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5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7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6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3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8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3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2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±0.5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448385" y="2466436"/>
            <a:ext cx="566341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arbohydrate contents in the control and the </a:t>
            </a:r>
            <a:r>
              <a:rPr lang="en-US" altLang="en-US" sz="16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utants.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590870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5352119"/>
              </p:ext>
            </p:extLst>
          </p:nvPr>
        </p:nvGraphicFramePr>
        <p:xfrm>
          <a:off x="721269" y="3252561"/>
          <a:ext cx="5265738" cy="254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Worksheet" r:id="rId4" imgW="5265388" imgH="2545139" progId="Excel.Sheet.12">
                  <p:embed/>
                </p:oleObj>
              </mc:Choice>
              <mc:Fallback>
                <p:oleObj name="Worksheet" r:id="rId4" imgW="5265388" imgH="2545139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21269" y="3252561"/>
                        <a:ext cx="5265738" cy="254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5799" y="2823210"/>
            <a:ext cx="583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primers used in this study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2228578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Theme1" id="{DE44A51C-D1B0-482C-B324-D50EC1267CD6}" vid="{E0F5F23E-BF44-4198-A1CE-F44931E0B07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4667</TotalTime>
  <Words>344</Words>
  <Application>Microsoft Macintosh PowerPoint</Application>
  <PresentationFormat>On-screen Show (4:3)</PresentationFormat>
  <Paragraphs>86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Theme1</vt:lpstr>
      <vt:lpstr>Worksheet</vt:lpstr>
      <vt:lpstr>PowerPoint Presentation</vt:lpstr>
      <vt:lpstr>PowerPoint Presentation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, Jongjin</dc:creator>
  <cp:lastModifiedBy>Zengyu Wang</cp:lastModifiedBy>
  <cp:revision>161</cp:revision>
  <cp:lastPrinted>2017-06-12T23:54:06Z</cp:lastPrinted>
  <dcterms:created xsi:type="dcterms:W3CDTF">2016-07-07T14:22:10Z</dcterms:created>
  <dcterms:modified xsi:type="dcterms:W3CDTF">2017-06-15T04:28:49Z</dcterms:modified>
</cp:coreProperties>
</file>